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 autoAdjust="0"/>
    <p:restoredTop sz="95482" autoAdjust="0"/>
  </p:normalViewPr>
  <p:slideViewPr>
    <p:cSldViewPr>
      <p:cViewPr>
        <p:scale>
          <a:sx n="100" d="100"/>
          <a:sy n="100" d="100"/>
        </p:scale>
        <p:origin x="-162" y="-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1992" y="-7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D901F0-4594-4895-9536-AF49D5B8F28C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7887E4-E812-4CFD-9896-807465D6CB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37213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6403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0122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6252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6452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5820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909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7254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894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2374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88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6927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1812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-99393" y="559061"/>
            <a:ext cx="7097065" cy="4589003"/>
            <a:chOff x="-99393" y="991109"/>
            <a:chExt cx="7097065" cy="4589003"/>
          </a:xfrm>
        </p:grpSpPr>
        <p:graphicFrame>
          <p:nvGraphicFramePr>
            <p:cNvPr id="2" name="Objec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39703143"/>
                </p:ext>
              </p:extLst>
            </p:nvPr>
          </p:nvGraphicFramePr>
          <p:xfrm>
            <a:off x="-99393" y="1115616"/>
            <a:ext cx="7097065" cy="446449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17" name="Prism 6" r:id="rId3" imgW="6839337" imgH="4302400" progId="Prism6.Document">
                    <p:embed/>
                  </p:oleObj>
                </mc:Choice>
                <mc:Fallback>
                  <p:oleObj name="Prism 6" r:id="rId3" imgW="6839337" imgH="4302400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-99393" y="1115616"/>
                          <a:ext cx="7097065" cy="446449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2"/>
            <p:cNvSpPr txBox="1"/>
            <p:nvPr/>
          </p:nvSpPr>
          <p:spPr>
            <a:xfrm>
              <a:off x="-27384" y="991109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a</a:t>
              </a:r>
              <a:endParaRPr lang="en-GB" sz="1600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276872" y="993086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b</a:t>
              </a:r>
              <a:endParaRPr lang="en-GB" sz="16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608512" y="993086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c</a:t>
              </a:r>
              <a:endParaRPr lang="en-GB" sz="16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-27384" y="2575285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d</a:t>
              </a:r>
              <a:endParaRPr lang="en-GB" sz="16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276872" y="2577262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e</a:t>
              </a:r>
              <a:endParaRPr lang="en-GB" sz="16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608512" y="2577262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f</a:t>
              </a:r>
              <a:endParaRPr lang="en-GB" sz="16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-27384" y="4015445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g</a:t>
              </a:r>
              <a:endParaRPr lang="en-GB" sz="16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276872" y="4017422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h</a:t>
              </a:r>
              <a:endParaRPr lang="en-GB" sz="1600" dirty="0"/>
            </a:p>
          </p:txBody>
        </p:sp>
      </p:grpSp>
      <p:sp>
        <p:nvSpPr>
          <p:cNvPr id="17" name="Rectangle 16"/>
          <p:cNvSpPr/>
          <p:nvPr/>
        </p:nvSpPr>
        <p:spPr>
          <a:xfrm>
            <a:off x="72008" y="5364088"/>
            <a:ext cx="666936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 smtClean="0"/>
              <a:t>Additional file 6.  </a:t>
            </a:r>
            <a:r>
              <a:rPr lang="en-GB" sz="1200" b="1" dirty="0"/>
              <a:t>Reproducibility of dexamethasone concentration response curves. </a:t>
            </a:r>
            <a:r>
              <a:rPr lang="en-GB" sz="1200" dirty="0"/>
              <a:t>Lung macrophages from 8 NS were used on two separate occasions – experiment 1 (grey circles) and experiment 2 (black triangles).</a:t>
            </a:r>
            <a:r>
              <a:rPr lang="en-GB" sz="1200" b="1" dirty="0"/>
              <a:t> </a:t>
            </a:r>
            <a:r>
              <a:rPr lang="en-GB" sz="1200" dirty="0"/>
              <a:t>Dexamethasone concentration response curves are shown for TNF-α.</a:t>
            </a:r>
          </a:p>
        </p:txBody>
      </p:sp>
    </p:spTree>
    <p:extLst>
      <p:ext uri="{BB962C8B-B14F-4D97-AF65-F5344CB8AC3E}">
        <p14:creationId xmlns:p14="http://schemas.microsoft.com/office/powerpoint/2010/main" val="7614843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27</TotalTime>
  <Words>53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6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Higham</dc:creator>
  <cp:lastModifiedBy>Andrew Higham</cp:lastModifiedBy>
  <cp:revision>112</cp:revision>
  <dcterms:created xsi:type="dcterms:W3CDTF">2014-07-22T13:15:53Z</dcterms:created>
  <dcterms:modified xsi:type="dcterms:W3CDTF">2015-06-11T10:10:27Z</dcterms:modified>
</cp:coreProperties>
</file>